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51A08-48B6-61EE-82BC-0FF6D3292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93977E-0C25-0952-9E61-56F1AEEFF7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B926D9-97F6-4C5D-6389-9F60A1B1F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CB2D7-3362-FE80-E5E6-BEEF580E7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C48399-2639-CF87-109C-4EF5C234E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545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F848D-0DE1-F04D-1B37-AA6EA1417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13ABFB-ADBC-8013-8969-49ECC1A51F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89A067-116D-7A8C-9E6F-7325E4BB9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870D03-1017-B6DB-9F17-874090CAC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887051-8B22-55C1-4393-823BE6D71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88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1F1448-6AB1-14A9-1677-4C048572DD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2FC922-2A42-8EFD-9F72-336C4FA486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E34EE6-8C82-A4D8-A21D-3688373A6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478D23-9BF9-2EFD-0189-F3962C99A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EFED3-BD36-A27C-9A28-6169B753F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499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7A06F-8955-EDA7-7907-95898D0CD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8D79D-145E-78D4-65D6-47EC58DD6A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CDBC10-6E33-9D84-7B91-54592C39E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3C7207-1A44-CE33-E7C8-A07BFA817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98DD2E-A3F8-295E-00DA-F46FC1BA1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737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94B38-E908-BB0D-6A33-0CAF2704E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59A7D7-0B8E-A1ED-5232-F9B5FE9894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ADB287-F8E0-7D34-6805-EB807A9D9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E32552-2297-3995-3315-B8771DBA2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84BB3-4356-0D41-D74C-AB25DE0B8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907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E1235-4D55-E45F-BF2A-1C157056C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080561-7FF4-8DC5-7C8D-BF53E2BD7E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AABE8E-C5F5-EAFF-2DA1-F2D1DC38F0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39D63-CE72-A776-126F-0AF116797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804195-F1E6-DE3E-F673-149205284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872D1D-A56F-5A6F-A97C-158582FF6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026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1B3BC-2732-A5D8-1C8B-3CE6775EFD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6D6DD7-9669-EE29-EE64-24BF3F7139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0A838B-3CCA-7EF7-3B92-44941B59DE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63CA2F-E30B-359E-8E1A-F193E94F43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AD1369-61EE-258B-9A6D-D451B3AE39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B1F5E1-3C91-79AC-A80D-12CFCE36B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2DD423-53AE-A59B-43D9-225A006E4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EF6F1C-E142-CD30-0EB9-AD89148A6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411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96888-3FFC-6B8D-72DC-7222FC8BBE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28ED11-1EB9-BEDD-5A8D-DFDAD06CA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85E1FA-5484-3B64-066B-0976D5226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2D3E1B-BE1F-D34C-8E7E-71FCE7346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473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963C4B-C961-FEF9-6EB4-23BA38B44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1CD95D-402C-5210-2277-C095A6628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51EF5B-1637-16F7-352A-6FA0AD207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60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C331E-3EBA-2981-E3E9-07F072CE4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CD6F4A-5064-B006-9D52-FB0E10874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A9B67C-848D-024E-D3F6-69D0450100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D7C452-A0DB-C22C-44BA-624319E23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D47A66-E719-8489-511F-D3DE1694C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A64BC3-7137-FA71-9013-449327899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541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AC73B-34DC-5DDF-B50B-A03B07BF12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82803A-DFAA-34C3-D4A0-7D91EFF6B2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30798D-9C66-B26A-E7C0-0507592302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5D8C63-EF06-A4CB-252A-C79989F5B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193B85-3C94-8F1D-2D9B-A389C4D4F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0C9B5C-4422-D9F8-AA0D-E51EEB3DC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60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5876A0-7F76-94CD-3A76-9C29B56ECF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3A5CB7-BF3E-5EC0-6D4F-F6454A8600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F99B8A-2FE0-827C-219C-0D60B44E6C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C7BE4E-6AFC-4069-A12C-5F15538D34B7}" type="datetimeFigureOut">
              <a:rPr lang="en-US" smtClean="0"/>
              <a:t>10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8FF03F-06DF-FE89-0878-B2430076DC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A89863-53EC-2729-1751-736817F33A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2EB2F7-250C-4304-ADF1-198D7BDD3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4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dots and numbers&#10;&#10;AI-generated content may be incorrect.">
            <a:extLst>
              <a:ext uri="{FF2B5EF4-FFF2-40B4-BE49-F238E27FC236}">
                <a16:creationId xmlns:a16="http://schemas.microsoft.com/office/drawing/2014/main" id="{F68179F9-5987-00F6-D2E3-A1915200BF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9192" y="427192"/>
            <a:ext cx="3751091" cy="3749627"/>
          </a:xfrm>
          <a:prstGeom prst="rect">
            <a:avLst/>
          </a:prstGeom>
        </p:spPr>
      </p:pic>
      <p:pic>
        <p:nvPicPr>
          <p:cNvPr id="8" name="Content Placeholder 7" descr="A diagram of a variety of dots&#10;&#10;AI-generated content may be incorrect.">
            <a:extLst>
              <a:ext uri="{FF2B5EF4-FFF2-40B4-BE49-F238E27FC236}">
                <a16:creationId xmlns:a16="http://schemas.microsoft.com/office/drawing/2014/main" id="{7DA16A1B-6ED9-8DD6-8F35-9CEB30EDFEC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7855" y="427192"/>
            <a:ext cx="3696538" cy="3696538"/>
          </a:xfr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8577A95-2B16-3984-64FB-9A527A29D67B}"/>
              </a:ext>
            </a:extLst>
          </p:cNvPr>
          <p:cNvSpPr txBox="1"/>
          <p:nvPr/>
        </p:nvSpPr>
        <p:spPr>
          <a:xfrm>
            <a:off x="1714001" y="407320"/>
            <a:ext cx="255198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A23C0D8-5B02-C1CA-10E6-F80C7028C785}"/>
              </a:ext>
            </a:extLst>
          </p:cNvPr>
          <p:cNvSpPr txBox="1"/>
          <p:nvPr/>
        </p:nvSpPr>
        <p:spPr>
          <a:xfrm>
            <a:off x="6496844" y="407319"/>
            <a:ext cx="255198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2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08DAD9A8-CE79-A819-5CC2-58AADC76015A}"/>
              </a:ext>
            </a:extLst>
          </p:cNvPr>
          <p:cNvSpPr txBox="1">
            <a:spLocks/>
          </p:cNvSpPr>
          <p:nvPr/>
        </p:nvSpPr>
        <p:spPr>
          <a:xfrm>
            <a:off x="3712552" y="4308308"/>
            <a:ext cx="4747847" cy="982083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762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Microbial composition by tumor location. </a:t>
            </a:r>
            <a:r>
              <a:rPr lang="en-US" sz="762" dirty="0">
                <a:latin typeface="Arial" panose="020B0604020202020204" pitchFamily="34" charset="0"/>
                <a:cs typeface="Arial" panose="020B0604020202020204" pitchFamily="34" charset="0"/>
              </a:rPr>
              <a:t>In the TCGA </a:t>
            </a:r>
            <a:r>
              <a:rPr lang="en-US" sz="762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762" dirty="0">
                <a:latin typeface="Arial" panose="020B0604020202020204" pitchFamily="34" charset="0"/>
                <a:cs typeface="Arial" panose="020B0604020202020204" pitchFamily="34" charset="0"/>
              </a:rPr>
              <a:t> and ORIEN </a:t>
            </a:r>
            <a:r>
              <a:rPr lang="en-US" sz="762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762" dirty="0">
                <a:latin typeface="Arial" panose="020B0604020202020204" pitchFamily="34" charset="0"/>
                <a:cs typeface="Arial" panose="020B0604020202020204" pitchFamily="34" charset="0"/>
              </a:rPr>
              <a:t> datasets, the whole-community non-metric multidimensional scaling values do not significantly group by primary site (PERMANOVA p-value 0.301 and 0.68, respectively)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5BB48FA-1AB6-4106-870F-DB9ADA15BF74}"/>
              </a:ext>
            </a:extLst>
          </p:cNvPr>
          <p:cNvSpPr txBox="1"/>
          <p:nvPr/>
        </p:nvSpPr>
        <p:spPr>
          <a:xfrm>
            <a:off x="96143" y="57948"/>
            <a:ext cx="28848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Supplementary Figure S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11355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8db864bc-821c-4dd3-a9c9-5002b5129ec6}" enabled="1" method="Standard" siteId="{0b95a125-791c-4f0a-9f9e-99e36311750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n, Ning</dc:creator>
  <cp:lastModifiedBy>Dahlberg, Angela</cp:lastModifiedBy>
  <cp:revision>2</cp:revision>
  <dcterms:created xsi:type="dcterms:W3CDTF">2025-09-09T02:34:31Z</dcterms:created>
  <dcterms:modified xsi:type="dcterms:W3CDTF">2025-10-16T20:17:12Z</dcterms:modified>
</cp:coreProperties>
</file>